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51" d="100"/>
          <a:sy n="51" d="100"/>
        </p:scale>
        <p:origin x="100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221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972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632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17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906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897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817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988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296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328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713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30C28-9D1F-4F50-AEDE-ACD108C7CA3E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B4EAB-953B-453A-B0A7-DB12BC7D02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949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kumimoji="1"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kumimoji="1"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22882DF-1B19-7D14-DB2F-4C398232DD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7179612"/>
              </p:ext>
            </p:extLst>
          </p:nvPr>
        </p:nvGraphicFramePr>
        <p:xfrm>
          <a:off x="2832426" y="1851147"/>
          <a:ext cx="6689658" cy="4646121"/>
        </p:xfrm>
        <a:graphic>
          <a:graphicData uri="http://schemas.openxmlformats.org/drawingml/2006/table">
            <a:tbl>
              <a:tblPr/>
              <a:tblGrid>
                <a:gridCol w="1285641">
                  <a:extLst>
                    <a:ext uri="{9D8B030D-6E8A-4147-A177-3AD203B41FA5}">
                      <a16:colId xmlns:a16="http://schemas.microsoft.com/office/drawing/2014/main" val="4082226719"/>
                    </a:ext>
                  </a:extLst>
                </a:gridCol>
                <a:gridCol w="1061765">
                  <a:extLst>
                    <a:ext uri="{9D8B030D-6E8A-4147-A177-3AD203B41FA5}">
                      <a16:colId xmlns:a16="http://schemas.microsoft.com/office/drawing/2014/main" val="2400120881"/>
                    </a:ext>
                  </a:extLst>
                </a:gridCol>
                <a:gridCol w="278256">
                  <a:extLst>
                    <a:ext uri="{9D8B030D-6E8A-4147-A177-3AD203B41FA5}">
                      <a16:colId xmlns:a16="http://schemas.microsoft.com/office/drawing/2014/main" val="1362077048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2202448241"/>
                    </a:ext>
                  </a:extLst>
                </a:gridCol>
                <a:gridCol w="278256">
                  <a:extLst>
                    <a:ext uri="{9D8B030D-6E8A-4147-A177-3AD203B41FA5}">
                      <a16:colId xmlns:a16="http://schemas.microsoft.com/office/drawing/2014/main" val="1157037491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2290470188"/>
                    </a:ext>
                  </a:extLst>
                </a:gridCol>
                <a:gridCol w="278256">
                  <a:extLst>
                    <a:ext uri="{9D8B030D-6E8A-4147-A177-3AD203B41FA5}">
                      <a16:colId xmlns:a16="http://schemas.microsoft.com/office/drawing/2014/main" val="3457857099"/>
                    </a:ext>
                  </a:extLst>
                </a:gridCol>
                <a:gridCol w="263611">
                  <a:extLst>
                    <a:ext uri="{9D8B030D-6E8A-4147-A177-3AD203B41FA5}">
                      <a16:colId xmlns:a16="http://schemas.microsoft.com/office/drawing/2014/main" val="2109466462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776640602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1333398771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3154541718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3632337087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2097412390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4055445596"/>
                    </a:ext>
                  </a:extLst>
                </a:gridCol>
                <a:gridCol w="263611">
                  <a:extLst>
                    <a:ext uri="{9D8B030D-6E8A-4147-A177-3AD203B41FA5}">
                      <a16:colId xmlns:a16="http://schemas.microsoft.com/office/drawing/2014/main" val="4227771333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3820272267"/>
                    </a:ext>
                  </a:extLst>
                </a:gridCol>
                <a:gridCol w="270933">
                  <a:extLst>
                    <a:ext uri="{9D8B030D-6E8A-4147-A177-3AD203B41FA5}">
                      <a16:colId xmlns:a16="http://schemas.microsoft.com/office/drawing/2014/main" val="3304889929"/>
                    </a:ext>
                  </a:extLst>
                </a:gridCol>
                <a:gridCol w="270932">
                  <a:extLst>
                    <a:ext uri="{9D8B030D-6E8A-4147-A177-3AD203B41FA5}">
                      <a16:colId xmlns:a16="http://schemas.microsoft.com/office/drawing/2014/main" val="803051205"/>
                    </a:ext>
                  </a:extLst>
                </a:gridCol>
              </a:tblGrid>
              <a:tr h="1272153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CU-LB-124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48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31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28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80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39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80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90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52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26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44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5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70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19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22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SCU-LB-141</a:t>
                      </a:r>
                    </a:p>
                  </a:txBody>
                  <a:tcPr marL="6844" marR="6844" marT="6844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343167"/>
                  </a:ext>
                </a:extLst>
              </a:tr>
              <a:tr h="27777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istology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8827958"/>
                  </a:ext>
                </a:extLst>
              </a:tr>
              <a:tr h="277778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utation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EN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6184502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IK3CA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9216433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TNNB1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729646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2972014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GFR2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016853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KRAS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9622579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BXW7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063554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PC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2135796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RBB4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3142622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RAS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0446186"/>
                  </a:ext>
                </a:extLst>
              </a:tr>
              <a:tr h="2777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LT3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4" marR="6844" marT="68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4959765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0D08938-5357-166C-5612-505A5184B224}"/>
              </a:ext>
            </a:extLst>
          </p:cNvPr>
          <p:cNvSpPr txBox="1"/>
          <p:nvPr/>
        </p:nvSpPr>
        <p:spPr>
          <a:xfrm>
            <a:off x="13755504" y="0"/>
            <a:ext cx="26196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Supple Fig.1</a:t>
            </a:r>
            <a:endParaRPr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A7BAFA44-3FCF-4398-3446-F0640AA65D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8204260"/>
              </p:ext>
            </p:extLst>
          </p:nvPr>
        </p:nvGraphicFramePr>
        <p:xfrm>
          <a:off x="10540980" y="3785737"/>
          <a:ext cx="3973697" cy="1049869"/>
        </p:xfrm>
        <a:graphic>
          <a:graphicData uri="http://schemas.openxmlformats.org/drawingml/2006/table">
            <a:tbl>
              <a:tblPr/>
              <a:tblGrid>
                <a:gridCol w="218069">
                  <a:extLst>
                    <a:ext uri="{9D8B030D-6E8A-4147-A177-3AD203B41FA5}">
                      <a16:colId xmlns:a16="http://schemas.microsoft.com/office/drawing/2014/main" val="3382302802"/>
                    </a:ext>
                  </a:extLst>
                </a:gridCol>
                <a:gridCol w="218069">
                  <a:extLst>
                    <a:ext uri="{9D8B030D-6E8A-4147-A177-3AD203B41FA5}">
                      <a16:colId xmlns:a16="http://schemas.microsoft.com/office/drawing/2014/main" val="1434347998"/>
                    </a:ext>
                  </a:extLst>
                </a:gridCol>
                <a:gridCol w="817108">
                  <a:extLst>
                    <a:ext uri="{9D8B030D-6E8A-4147-A177-3AD203B41FA5}">
                      <a16:colId xmlns:a16="http://schemas.microsoft.com/office/drawing/2014/main" val="1911301901"/>
                    </a:ext>
                  </a:extLst>
                </a:gridCol>
                <a:gridCol w="62091">
                  <a:extLst>
                    <a:ext uri="{9D8B030D-6E8A-4147-A177-3AD203B41FA5}">
                      <a16:colId xmlns:a16="http://schemas.microsoft.com/office/drawing/2014/main" val="1248847979"/>
                    </a:ext>
                  </a:extLst>
                </a:gridCol>
                <a:gridCol w="443060">
                  <a:extLst>
                    <a:ext uri="{9D8B030D-6E8A-4147-A177-3AD203B41FA5}">
                      <a16:colId xmlns:a16="http://schemas.microsoft.com/office/drawing/2014/main" val="3515773754"/>
                    </a:ext>
                  </a:extLst>
                </a:gridCol>
                <a:gridCol w="443060">
                  <a:extLst>
                    <a:ext uri="{9D8B030D-6E8A-4147-A177-3AD203B41FA5}">
                      <a16:colId xmlns:a16="http://schemas.microsoft.com/office/drawing/2014/main" val="2169955945"/>
                    </a:ext>
                  </a:extLst>
                </a:gridCol>
                <a:gridCol w="443060">
                  <a:extLst>
                    <a:ext uri="{9D8B030D-6E8A-4147-A177-3AD203B41FA5}">
                      <a16:colId xmlns:a16="http://schemas.microsoft.com/office/drawing/2014/main" val="3592965325"/>
                    </a:ext>
                  </a:extLst>
                </a:gridCol>
                <a:gridCol w="443060">
                  <a:extLst>
                    <a:ext uri="{9D8B030D-6E8A-4147-A177-3AD203B41FA5}">
                      <a16:colId xmlns:a16="http://schemas.microsoft.com/office/drawing/2014/main" val="2652004082"/>
                    </a:ext>
                  </a:extLst>
                </a:gridCol>
                <a:gridCol w="443060">
                  <a:extLst>
                    <a:ext uri="{9D8B030D-6E8A-4147-A177-3AD203B41FA5}">
                      <a16:colId xmlns:a16="http://schemas.microsoft.com/office/drawing/2014/main" val="1333090567"/>
                    </a:ext>
                  </a:extLst>
                </a:gridCol>
                <a:gridCol w="443060">
                  <a:extLst>
                    <a:ext uri="{9D8B030D-6E8A-4147-A177-3AD203B41FA5}">
                      <a16:colId xmlns:a16="http://schemas.microsoft.com/office/drawing/2014/main" val="214398434"/>
                    </a:ext>
                  </a:extLst>
                </a:gridCol>
              </a:tblGrid>
              <a:tr h="423333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istology</a:t>
                      </a: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8818358"/>
                  </a:ext>
                </a:extLst>
              </a:tr>
              <a:tr h="30649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33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dometrial hyperplasia</a:t>
                      </a: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20893587"/>
                  </a:ext>
                </a:extLst>
              </a:tr>
              <a:tr h="30649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FF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dometrial polyp</a:t>
                      </a: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5073681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DDB01129-2B4F-D761-9899-52C00CF675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4198445"/>
              </p:ext>
            </p:extLst>
          </p:nvPr>
        </p:nvGraphicFramePr>
        <p:xfrm>
          <a:off x="10540979" y="5134131"/>
          <a:ext cx="3907796" cy="1363137"/>
        </p:xfrm>
        <a:graphic>
          <a:graphicData uri="http://schemas.openxmlformats.org/drawingml/2006/table">
            <a:tbl>
              <a:tblPr/>
              <a:tblGrid>
                <a:gridCol w="224565">
                  <a:extLst>
                    <a:ext uri="{9D8B030D-6E8A-4147-A177-3AD203B41FA5}">
                      <a16:colId xmlns:a16="http://schemas.microsoft.com/office/drawing/2014/main" val="3703526299"/>
                    </a:ext>
                  </a:extLst>
                </a:gridCol>
                <a:gridCol w="380770">
                  <a:extLst>
                    <a:ext uri="{9D8B030D-6E8A-4147-A177-3AD203B41FA5}">
                      <a16:colId xmlns:a16="http://schemas.microsoft.com/office/drawing/2014/main" val="58676823"/>
                    </a:ext>
                  </a:extLst>
                </a:gridCol>
                <a:gridCol w="1306996">
                  <a:extLst>
                    <a:ext uri="{9D8B030D-6E8A-4147-A177-3AD203B41FA5}">
                      <a16:colId xmlns:a16="http://schemas.microsoft.com/office/drawing/2014/main" val="2392433495"/>
                    </a:ext>
                  </a:extLst>
                </a:gridCol>
                <a:gridCol w="1995465">
                  <a:extLst>
                    <a:ext uri="{9D8B030D-6E8A-4147-A177-3AD203B41FA5}">
                      <a16:colId xmlns:a16="http://schemas.microsoft.com/office/drawing/2014/main" val="1954053270"/>
                    </a:ext>
                  </a:extLst>
                </a:gridCol>
              </a:tblGrid>
              <a:tr h="423333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umber of mutations</a:t>
                      </a: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12367208"/>
                  </a:ext>
                </a:extLst>
              </a:tr>
              <a:tr h="30649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8670848"/>
                  </a:ext>
                </a:extLst>
              </a:tr>
              <a:tr h="30649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2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1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4766833"/>
                  </a:ext>
                </a:extLst>
              </a:tr>
              <a:tr h="30649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8468" marR="8468" marT="84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8468" marR="8468" marT="8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706642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5980522-4500-8130-B3A5-FA607DBE4E78}"/>
              </a:ext>
            </a:extLst>
          </p:cNvPr>
          <p:cNvSpPr txBox="1"/>
          <p:nvPr/>
        </p:nvSpPr>
        <p:spPr>
          <a:xfrm>
            <a:off x="1172128" y="7451956"/>
            <a:ext cx="14327702" cy="29435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. </a:t>
            </a:r>
          </a:p>
          <a:p>
            <a:pPr algn="just">
              <a:lnSpc>
                <a:spcPct val="200000"/>
              </a:lnSpc>
            </a:pPr>
            <a:r>
              <a:rPr lang="en-US" altLang="ja-JP" sz="2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thogenic mutations in the 16 samples with premalignant diseases. The color of each column represents the number of pathogenic/likely-pathogenic mutations in the sample. Histological classification of the sample is shown in the color chart.</a:t>
            </a:r>
            <a:endParaRPr lang="ja-JP" altLang="ja-JP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540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</TotalTime>
  <Words>301</Words>
  <Application>Microsoft Office PowerPoint</Application>
  <PresentationFormat>ユーザー設定</PresentationFormat>
  <Paragraphs>2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根　希世子</dc:creator>
  <cp:lastModifiedBy>古川　洋一</cp:lastModifiedBy>
  <cp:revision>8</cp:revision>
  <dcterms:created xsi:type="dcterms:W3CDTF">2023-04-13T23:54:44Z</dcterms:created>
  <dcterms:modified xsi:type="dcterms:W3CDTF">2023-05-25T02:36:15Z</dcterms:modified>
</cp:coreProperties>
</file>